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516" autoAdjust="0"/>
  </p:normalViewPr>
  <p:slideViewPr>
    <p:cSldViewPr>
      <p:cViewPr>
        <p:scale>
          <a:sx n="100" d="100"/>
          <a:sy n="100" d="100"/>
        </p:scale>
        <p:origin x="-30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679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220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898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722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97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051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651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857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403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57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42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5E32B-5784-4606-AEE1-9B48E9FD6DE5}" type="datetimeFigureOut">
              <a:rPr lang="en-US" smtClean="0"/>
              <a:t>11/9/2014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B68A6-872A-43C3-9655-A35E9DE6306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139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6" y="3081878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6" y="188640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6" y="452849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6" y="1635259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188640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164817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308833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452849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6689" y="188640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6689" y="1635259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6689" y="3081878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36689" y="452849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ZoneTexte 1"/>
          <p:cNvSpPr txBox="1"/>
          <p:nvPr/>
        </p:nvSpPr>
        <p:spPr>
          <a:xfrm>
            <a:off x="717897" y="6093296"/>
            <a:ext cx="7814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smtClean="0">
                <a:latin typeface="Arial" panose="020B0604020202020204" pitchFamily="34" charset="0"/>
                <a:cs typeface="Arial" panose="020B0604020202020204" pitchFamily="34" charset="0"/>
              </a:rPr>
              <a:t>Figure S1: 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Decay of r</a:t>
            </a:r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 along physical distance [in kb] in the indica panel. R</a:t>
            </a:r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 was averaged across marker pairs for 25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kb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intervals</a:t>
            </a:r>
            <a:r>
              <a:rPr lang="fr-FR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200038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1642858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8" y="3085678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05226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428" y="27245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428" y="1705836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428" y="313922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428" y="4572605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016" y="27245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016" y="171283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016" y="315321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016" y="4593590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874" y="272451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874" y="1736479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874" y="3200507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97874" y="4664534"/>
            <a:ext cx="2379619" cy="1428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ZoneTexte 14"/>
          <p:cNvSpPr txBox="1"/>
          <p:nvPr/>
        </p:nvSpPr>
        <p:spPr>
          <a:xfrm>
            <a:off x="717897" y="6021288"/>
            <a:ext cx="7814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smtClean="0">
                <a:latin typeface="Arial" panose="020B0604020202020204" pitchFamily="34" charset="0"/>
                <a:cs typeface="Arial" panose="020B0604020202020204" pitchFamily="34" charset="0"/>
              </a:rPr>
              <a:t>Figure S2: 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Decay of r</a:t>
            </a:r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 along physical distance [in kb] in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japonica panel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. R</a:t>
            </a:r>
            <a:r>
              <a:rPr lang="en-US" sz="1400" baseline="300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 was averaged across marker pairs for 25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kb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intervals</a:t>
            </a:r>
            <a:r>
              <a:rPr lang="fr-FR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FR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754881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</TotalTime>
  <Words>56</Words>
  <Application>Microsoft Office PowerPoint</Application>
  <PresentationFormat>Affichage à l'écran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urtois</dc:creator>
  <cp:lastModifiedBy>Brigitte</cp:lastModifiedBy>
  <cp:revision>33</cp:revision>
  <dcterms:created xsi:type="dcterms:W3CDTF">2014-05-06T09:14:14Z</dcterms:created>
  <dcterms:modified xsi:type="dcterms:W3CDTF">2014-11-09T17:51:50Z</dcterms:modified>
</cp:coreProperties>
</file>